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792E6-05B7-4A96-A225-83DABD9F87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D8FCF-C30B-4A10-84A3-4EF55C3201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75241-3186-4E2D-A506-E22E302F1E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642315-82BE-4F53-8CDE-178D31FB9A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BDC82-A30A-47F2-B3D1-2059FFC0E2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53EDF9-F300-43C3-AE3C-1D0381ED28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FA6DE-1A92-4B35-8C55-9A515C1D7B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B727DE-8023-4ECA-B1BB-853D0D6B74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86736-5B6A-46C7-9745-8A68251D60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56E42-84CE-4E1D-8901-58051FFC87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328E9-A4E1-4CEA-8A4B-8E3E8BF372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D5378-B605-4B7E-9424-3BE30F876F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E44803-A450-44C5-A958-8243FD77E095}" type="slidenum">
              <a:rPr b="0" lang="de-CH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3841560" y="692280"/>
            <a:ext cx="165564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t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ssessed for eligibility (n=3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4"/>
          <p:cNvSpPr/>
          <p:nvPr/>
        </p:nvSpPr>
        <p:spPr>
          <a:xfrm>
            <a:off x="4643280" y="1197000"/>
            <a:ext cx="12960" cy="2087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5186520" y="1446120"/>
            <a:ext cx="2625480" cy="795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cluded (n=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t meeting inclusion criteria (n=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7"/>
          <p:cNvSpPr/>
          <p:nvPr/>
        </p:nvSpPr>
        <p:spPr>
          <a:xfrm>
            <a:off x="4656240" y="1846440"/>
            <a:ext cx="530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1"/>
          <p:cNvSpPr/>
          <p:nvPr/>
        </p:nvSpPr>
        <p:spPr>
          <a:xfrm>
            <a:off x="1692360" y="3645000"/>
            <a:ext cx="1501560" cy="647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4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/MDMA/Amph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4"/>
          <p:cNvSpPr/>
          <p:nvPr/>
        </p:nvSpPr>
        <p:spPr>
          <a:xfrm>
            <a:off x="3959280" y="32846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5"/>
          <p:cNvSpPr/>
          <p:nvPr/>
        </p:nvSpPr>
        <p:spPr>
          <a:xfrm>
            <a:off x="5405400" y="32846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8"/>
          <p:cNvSpPr/>
          <p:nvPr/>
        </p:nvSpPr>
        <p:spPr>
          <a:xfrm>
            <a:off x="3708360" y="328464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1"/>
          <p:cNvSpPr/>
          <p:nvPr/>
        </p:nvSpPr>
        <p:spPr>
          <a:xfrm>
            <a:off x="5126040" y="4551480"/>
            <a:ext cx="3838680" cy="641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rop outs (n=2) (one before first study drug administration, one completed all sessions with the exception of the LSD sess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2"/>
          <p:cNvSpPr/>
          <p:nvPr/>
        </p:nvSpPr>
        <p:spPr>
          <a:xfrm>
            <a:off x="4656240" y="4869000"/>
            <a:ext cx="4460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3"/>
          <p:cNvSpPr/>
          <p:nvPr/>
        </p:nvSpPr>
        <p:spPr>
          <a:xfrm>
            <a:off x="1116000" y="5877000"/>
            <a:ext cx="7343640" cy="504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alysed (n=2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cluded from analysis of </a:t>
            </a:r>
            <a:r>
              <a:rPr b="0" lang="de-CH" sz="1200" spc="-1" strike="noStrike">
                <a:solidFill>
                  <a:srgbClr val="000000"/>
                </a:solidFill>
                <a:latin typeface="Arial"/>
              </a:rPr>
              <a:t>4 (due to insufficient quality of MRI dat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4"/>
          <p:cNvSpPr/>
          <p:nvPr/>
        </p:nvSpPr>
        <p:spPr>
          <a:xfrm>
            <a:off x="4656240" y="4500720"/>
            <a:ext cx="0" cy="1376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"/>
          <p:cNvSpPr/>
          <p:nvPr/>
        </p:nvSpPr>
        <p:spPr>
          <a:xfrm>
            <a:off x="3895560" y="2492280"/>
            <a:ext cx="1540080" cy="289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andomized (n=29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8"/>
          <p:cNvSpPr/>
          <p:nvPr/>
        </p:nvSpPr>
        <p:spPr>
          <a:xfrm>
            <a:off x="3708360" y="450864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7"/>
          <p:cNvSpPr/>
          <p:nvPr/>
        </p:nvSpPr>
        <p:spPr>
          <a:xfrm>
            <a:off x="3708360" y="429264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7"/>
          <p:cNvSpPr/>
          <p:nvPr/>
        </p:nvSpPr>
        <p:spPr>
          <a:xfrm>
            <a:off x="5724360" y="430848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0"/>
          <p:cNvSpPr/>
          <p:nvPr/>
        </p:nvSpPr>
        <p:spPr>
          <a:xfrm>
            <a:off x="2916360" y="5227560"/>
            <a:ext cx="3506760" cy="289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articipants completed the study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bgerundetes Rechteck 5"/>
          <p:cNvSpPr/>
          <p:nvPr/>
        </p:nvSpPr>
        <p:spPr>
          <a:xfrm>
            <a:off x="3059280" y="549360"/>
            <a:ext cx="1017360" cy="28728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roll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bgerundetes Rechteck 36"/>
          <p:cNvSpPr/>
          <p:nvPr/>
        </p:nvSpPr>
        <p:spPr>
          <a:xfrm>
            <a:off x="324000" y="3500280"/>
            <a:ext cx="1017360" cy="28908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llo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bgerundetes Rechteck 37"/>
          <p:cNvSpPr/>
          <p:nvPr/>
        </p:nvSpPr>
        <p:spPr>
          <a:xfrm>
            <a:off x="324000" y="5711760"/>
            <a:ext cx="1017360" cy="28728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feld 2"/>
          <p:cNvSpPr/>
          <p:nvPr/>
        </p:nvSpPr>
        <p:spPr>
          <a:xfrm>
            <a:off x="339120" y="549360"/>
            <a:ext cx="25520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STUD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LSD = 100 µ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MDMA= 125 m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CH" sz="1800" spc="-1" strike="noStrike">
                <a:solidFill>
                  <a:srgbClr val="000000"/>
                </a:solidFill>
                <a:latin typeface="Arial"/>
              </a:rPr>
              <a:t>d-Amphetamine: 40 m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8"/>
          <p:cNvSpPr/>
          <p:nvPr/>
        </p:nvSpPr>
        <p:spPr>
          <a:xfrm>
            <a:off x="5538960" y="3284640"/>
            <a:ext cx="1333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8"/>
          <p:cNvSpPr/>
          <p:nvPr/>
        </p:nvSpPr>
        <p:spPr>
          <a:xfrm>
            <a:off x="2411280" y="3282840"/>
            <a:ext cx="14050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4"/>
          <p:cNvSpPr/>
          <p:nvPr/>
        </p:nvSpPr>
        <p:spPr>
          <a:xfrm>
            <a:off x="2421000" y="329076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4"/>
          <p:cNvSpPr/>
          <p:nvPr/>
        </p:nvSpPr>
        <p:spPr>
          <a:xfrm>
            <a:off x="6872400" y="32828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1"/>
          <p:cNvSpPr/>
          <p:nvPr/>
        </p:nvSpPr>
        <p:spPr>
          <a:xfrm>
            <a:off x="3241800" y="3651120"/>
            <a:ext cx="1500120" cy="649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5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/MDMA/Amph (n=2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1"/>
          <p:cNvSpPr/>
          <p:nvPr/>
        </p:nvSpPr>
        <p:spPr>
          <a:xfrm>
            <a:off x="4797360" y="3651120"/>
            <a:ext cx="1500120" cy="649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5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mph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/MDMA/Pla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1"/>
          <p:cNvSpPr/>
          <p:nvPr/>
        </p:nvSpPr>
        <p:spPr>
          <a:xfrm>
            <a:off x="6353280" y="3660840"/>
            <a:ext cx="1500120" cy="647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4000"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DMA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SD/Pla/Amph (n=2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2T13:11:47Z</dcterms:created>
  <dc:creator>LiechtiM</dc:creator>
  <dc:description/>
  <dc:language>en-US</dc:language>
  <cp:lastModifiedBy>Felix Müller</cp:lastModifiedBy>
  <dcterms:modified xsi:type="dcterms:W3CDTF">2020-06-18T09:16:49Z</dcterms:modified>
  <cp:revision>23</cp:revision>
  <dc:subject/>
  <dc:title>Folie 1</dc:title>
</cp:coreProperties>
</file>